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354" y="-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AB932-61FE-4719-A470-4B7AB682D582}" type="datetimeFigureOut">
              <a:rPr lang="en-GB" smtClean="0"/>
              <a:t>15/07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9C7A86-D50F-4729-A776-7AD98A0F6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8929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3-fold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9C7A86-D50F-4729-A776-7AD98A0F607C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7883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5-fold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9C7A86-D50F-4729-A776-7AD98A0F607C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613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/>
              <a:t>7/1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11560" y="1028343"/>
            <a:ext cx="792088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smtClean="0"/>
              <a:t>Supplementary Figure 1. </a:t>
            </a:r>
            <a:r>
              <a:rPr lang="en-GB" b="1" dirty="0"/>
              <a:t>  </a:t>
            </a:r>
            <a:r>
              <a:rPr lang="en-GB" dirty="0" err="1"/>
              <a:t>Heatmaps</a:t>
            </a:r>
            <a:r>
              <a:rPr lang="en-GB" dirty="0"/>
              <a:t> showing statistically significant changes in SELDI peak intensity from “gold standard” processing condition (+PI/immediate processing).</a:t>
            </a:r>
            <a:r>
              <a:rPr lang="en-GB" b="1" dirty="0"/>
              <a:t> </a:t>
            </a:r>
            <a:r>
              <a:rPr lang="en-GB" dirty="0"/>
              <a:t>Patients (A-J) are represented by columns with sub-columns representing each sample processing condition (-PI/immediate processing or +/- PI delayed processing at 4</a:t>
            </a:r>
            <a:r>
              <a:rPr lang="en-GB" baseline="30000" dirty="0"/>
              <a:t>o</a:t>
            </a:r>
            <a:r>
              <a:rPr lang="en-GB" dirty="0"/>
              <a:t>C or room temperature (20-22</a:t>
            </a:r>
            <a:r>
              <a:rPr lang="en-GB" baseline="30000" dirty="0"/>
              <a:t>o</a:t>
            </a:r>
            <a:r>
              <a:rPr lang="en-GB" dirty="0"/>
              <a:t>C)). Rows represent SELDI peaks arranged by m/z ratio . Increases in peak intensity of a). </a:t>
            </a:r>
            <a:r>
              <a:rPr lang="en-GB" dirty="0" smtClean="0"/>
              <a:t>3-fold </a:t>
            </a:r>
            <a:r>
              <a:rPr lang="en-GB" dirty="0"/>
              <a:t>or greater or b). </a:t>
            </a:r>
            <a:r>
              <a:rPr lang="en-GB" dirty="0" smtClean="0"/>
              <a:t>5-fold </a:t>
            </a:r>
            <a:r>
              <a:rPr lang="en-GB" dirty="0"/>
              <a:t>or greater, that are significant at P &lt; 0.001 are represented by black rectangles and similarly significant decreases in peak intensity are represented by white rectangles. </a:t>
            </a:r>
          </a:p>
        </p:txBody>
      </p:sp>
    </p:spTree>
    <p:extLst>
      <p:ext uri="{BB962C8B-B14F-4D97-AF65-F5344CB8AC3E}">
        <p14:creationId xmlns:p14="http://schemas.microsoft.com/office/powerpoint/2010/main" val="6545876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" y="266700"/>
            <a:ext cx="8972550" cy="633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51520" y="82034"/>
            <a:ext cx="2041136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Supplementary Figure 1a</a:t>
            </a:r>
            <a:endParaRPr lang="en-GB" sz="14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" y="266700"/>
            <a:ext cx="8972550" cy="6334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51520" y="82034"/>
            <a:ext cx="204915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Supplementary Figure 1b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677395757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9</TotalTime>
  <Words>14</Words>
  <Application>Microsoft Office PowerPoint</Application>
  <PresentationFormat>On-screen Show (4:3)</PresentationFormat>
  <Paragraphs>7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Blank</vt:lpstr>
      <vt:lpstr>PowerPoint Presentation</vt:lpstr>
      <vt:lpstr>PowerPoint Presentation</vt:lpstr>
      <vt:lpstr>PowerPoint Presentation</vt:lpstr>
    </vt:vector>
  </TitlesOfParts>
  <Company>University of Leed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Cairns</dc:creator>
  <cp:lastModifiedBy>Roz</cp:lastModifiedBy>
  <cp:revision>4</cp:revision>
  <dcterms:created xsi:type="dcterms:W3CDTF">2014-07-15T12:56:09Z</dcterms:created>
  <dcterms:modified xsi:type="dcterms:W3CDTF">2014-07-15T20:17:12Z</dcterms:modified>
</cp:coreProperties>
</file>